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905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919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197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9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864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4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52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47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608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289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262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8689B-919A-D346-8DB2-9C18BAA9E612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1750-1ACC-E14E-A33E-662B072241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0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F491CDB-0882-524D-BA6A-99C2F358E3B2}"/>
              </a:ext>
            </a:extLst>
          </p:cNvPr>
          <p:cNvSpPr txBox="1"/>
          <p:nvPr/>
        </p:nvSpPr>
        <p:spPr>
          <a:xfrm>
            <a:off x="400665" y="5433630"/>
            <a:ext cx="8651592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ov</a:t>
            </a:r>
            <a:r>
              <a:rPr lang="en-US" altLang="ja-JP" sz="1100" b="1">
                <a:latin typeface="Arial" panose="020B0604020202020204" pitchFamily="34" charset="0"/>
                <a:cs typeface="Arial" panose="020B0604020202020204" pitchFamily="34" charset="0"/>
              </a:rPr>
              <a:t>. 1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. Video of 3D tracking of multi-headed marmosets using Lidar and video tracking.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a) Raw video frame. (b) 3D coordinates of marmosets detected using Lidar. White point: centroid of marmosets, white box: virtual space of the cage. (c) Location of marmosets on video frame detected using Yolo, box : detected marmosets. (d) 3D coordinates of marmosets calculated using video tracking, colored point: coordinate of marmoset. (e, f) Individual information added to C and D using face identification; green: marmoset A, red: marmoset B, yellow: marmoset C.</a:t>
            </a:r>
            <a:endParaRPr lang="ja-JP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media1">
            <a:hlinkClick r:id="" action="ppaction://media"/>
            <a:extLst>
              <a:ext uri="{FF2B5EF4-FFF2-40B4-BE49-F238E27FC236}">
                <a16:creationId xmlns:a16="http://schemas.microsoft.com/office/drawing/2014/main" id="{C8C8B90D-0805-0A79-02E1-522FBB10771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38403" y="0"/>
            <a:ext cx="6776115" cy="50820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32300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983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0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晃海 圦本</dc:creator>
  <cp:lastModifiedBy>晃海 圦本</cp:lastModifiedBy>
  <cp:revision>7</cp:revision>
  <dcterms:created xsi:type="dcterms:W3CDTF">2023-07-18T01:28:01Z</dcterms:created>
  <dcterms:modified xsi:type="dcterms:W3CDTF">2024-01-18T11:42:28Z</dcterms:modified>
</cp:coreProperties>
</file>